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331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EADCF0B9-ACCD-81BD-43C8-0FD52393F3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000" y="505303"/>
            <a:ext cx="5760000" cy="667873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ED0ABC2-2F35-D02A-7B3C-B5B1E69E7943}"/>
              </a:ext>
            </a:extLst>
          </p:cNvPr>
          <p:cNvSpPr txBox="1"/>
          <p:nvPr/>
        </p:nvSpPr>
        <p:spPr>
          <a:xfrm>
            <a:off x="663675" y="7597676"/>
            <a:ext cx="57600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</a:p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ibution of angiotensin II (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ype 1 receptor (AGTR1)/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 to bladder cancer cell migration and proliferation in vitro. (A, B)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vasion assay comparing AGTR1-overexpressing (AGTR1) and control (Ctrl) T24 cells (A), and Ctrl cells with or without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(B). Data are presented as mean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ndard error of the mean (SEM) of the triplicate measurement of healed distance relative to Ctrl (A) and without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. Representative results from two independent experiments are shown. (C) Proliferative responses of AGTR1 and Ctrl cells (left) and AGTR1 cells treated with or without 10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presence or absence of 3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sartan (LOS) (right). Data are presented as mean ± SEM of quadruplicate measurements of absorbance at 450 nm.  Representative results from three independent experiments are shown. ns, not significant.</a:t>
            </a:r>
          </a:p>
        </p:txBody>
      </p:sp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73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神沼　修</cp:lastModifiedBy>
  <cp:revision>3</cp:revision>
  <dcterms:created xsi:type="dcterms:W3CDTF">2025-07-04T02:55:30Z</dcterms:created>
  <dcterms:modified xsi:type="dcterms:W3CDTF">2025-10-22T01:44:29Z</dcterms:modified>
</cp:coreProperties>
</file>